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578" autoAdjust="0"/>
  </p:normalViewPr>
  <p:slideViewPr>
    <p:cSldViewPr>
      <p:cViewPr varScale="1">
        <p:scale>
          <a:sx n="128" d="100"/>
          <a:sy n="128" d="100"/>
        </p:scale>
        <p:origin x="-123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w-wfiler02\goek\Allgemein\User\yas\Publikation%20-%20Masterarbeit\BMC%20Anaesthesia\Einreichung\Additional%20file%20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4485899614971036"/>
          <c:y val="2.186878727634195E-2"/>
          <c:w val="0.47103957820250442"/>
          <c:h val="0.8849736228299494"/>
        </c:manualLayout>
      </c:layout>
      <c:barChart>
        <c:barDir val="bar"/>
        <c:grouping val="clustered"/>
        <c:varyColors val="0"/>
        <c:ser>
          <c:idx val="2"/>
          <c:order val="0"/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cat>
            <c:strRef>
              <c:f>'[1]ICER Tornado Diagram GBP'!$J$54:$J$63</c:f>
              <c:strCache>
                <c:ptCount val="10"/>
                <c:pt idx="0">
                  <c:v>Probability for complication on the first attempt (UG) lower-/ upper bound of CI</c:v>
                </c:pt>
                <c:pt idx="1">
                  <c:v>Probability for an arterial puncture (LM) lower-/ upper bound of CI</c:v>
                </c:pt>
                <c:pt idx="2">
                  <c:v>Costs of treating haematomediastinum +/- 50% </c:v>
                </c:pt>
                <c:pt idx="3">
                  <c:v>Costs of treating thrombosis +/- 50% </c:v>
                </c:pt>
                <c:pt idx="4">
                  <c:v>Costs of treating embolism +/- 50% </c:v>
                </c:pt>
                <c:pt idx="5">
                  <c:v>Costs of treating hydromediastinum +/- 50% </c:v>
                </c:pt>
                <c:pt idx="6">
                  <c:v>Costs of treating haematothorax +/- 50% </c:v>
                </c:pt>
                <c:pt idx="7">
                  <c:v>Costs of treating pneumothorax +/- 50% </c:v>
                </c:pt>
                <c:pt idx="8">
                  <c:v>Costs of treating hydrothorax +/- 50% </c:v>
                </c:pt>
                <c:pt idx="9">
                  <c:v>Costs of treating nerve injury +/- 50% </c:v>
                </c:pt>
              </c:strCache>
            </c:strRef>
          </c:cat>
          <c:val>
            <c:numRef>
              <c:f>'[1]ICER Tornado Diagram GBP'!$M$54:$M$63</c:f>
              <c:numCache>
                <c:formatCode>General</c:formatCode>
                <c:ptCount val="10"/>
                <c:pt idx="0">
                  <c:v>-1300.8620562303913</c:v>
                </c:pt>
                <c:pt idx="1">
                  <c:v>-1314.0061164552501</c:v>
                </c:pt>
                <c:pt idx="2">
                  <c:v>-1335.47587870649</c:v>
                </c:pt>
                <c:pt idx="3">
                  <c:v>-1352.4609563562874</c:v>
                </c:pt>
                <c:pt idx="4">
                  <c:v>-1352.4609563562874</c:v>
                </c:pt>
                <c:pt idx="5">
                  <c:v>-1353.2993917179817</c:v>
                </c:pt>
                <c:pt idx="6">
                  <c:v>-1373.1063002087476</c:v>
                </c:pt>
                <c:pt idx="7">
                  <c:v>-1373.6652571165439</c:v>
                </c:pt>
                <c:pt idx="8">
                  <c:v>-1391.0740601641858</c:v>
                </c:pt>
                <c:pt idx="9">
                  <c:v>-1449.4399798588702</c:v>
                </c:pt>
              </c:numCache>
            </c:numRef>
          </c:val>
        </c:ser>
        <c:ser>
          <c:idx val="3"/>
          <c:order val="1"/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cat>
            <c:strRef>
              <c:f>'[1]ICER Tornado Diagram GBP'!$J$54:$J$63</c:f>
              <c:strCache>
                <c:ptCount val="10"/>
                <c:pt idx="0">
                  <c:v>Probability for complication on the first attempt (UG) lower-/ upper bound of CI</c:v>
                </c:pt>
                <c:pt idx="1">
                  <c:v>Probability for an arterial puncture (LM) lower-/ upper bound of CI</c:v>
                </c:pt>
                <c:pt idx="2">
                  <c:v>Costs of treating haematomediastinum +/- 50% </c:v>
                </c:pt>
                <c:pt idx="3">
                  <c:v>Costs of treating thrombosis +/- 50% </c:v>
                </c:pt>
                <c:pt idx="4">
                  <c:v>Costs of treating embolism +/- 50% </c:v>
                </c:pt>
                <c:pt idx="5">
                  <c:v>Costs of treating hydromediastinum +/- 50% </c:v>
                </c:pt>
                <c:pt idx="6">
                  <c:v>Costs of treating haematothorax +/- 50% </c:v>
                </c:pt>
                <c:pt idx="7">
                  <c:v>Costs of treating pneumothorax +/- 50% </c:v>
                </c:pt>
                <c:pt idx="8">
                  <c:v>Costs of treating hydrothorax +/- 50% </c:v>
                </c:pt>
                <c:pt idx="9">
                  <c:v>Costs of treating nerve injury +/- 50% </c:v>
                </c:pt>
              </c:strCache>
            </c:strRef>
          </c:cat>
          <c:val>
            <c:numRef>
              <c:f>'[1]ICER Tornado Diagram GBP'!$N$54:$N$63</c:f>
              <c:numCache>
                <c:formatCode>General</c:formatCode>
                <c:ptCount val="10"/>
                <c:pt idx="0">
                  <c:v>-1284.5021783158134</c:v>
                </c:pt>
                <c:pt idx="1">
                  <c:v>-1271.149037099281</c:v>
                </c:pt>
                <c:pt idx="2">
                  <c:v>-1251.0102775913383</c:v>
                </c:pt>
                <c:pt idx="3">
                  <c:v>-1234.0432308095346</c:v>
                </c:pt>
                <c:pt idx="4">
                  <c:v>-1234.0432308095346</c:v>
                </c:pt>
                <c:pt idx="5">
                  <c:v>-1233.2047954478408</c:v>
                </c:pt>
                <c:pt idx="6">
                  <c:v>-1213.3798560890807</c:v>
                </c:pt>
                <c:pt idx="7">
                  <c:v>-1212.8208991812851</c:v>
                </c:pt>
                <c:pt idx="8">
                  <c:v>-1195.4301270016358</c:v>
                </c:pt>
                <c:pt idx="9">
                  <c:v>-1137.0551918729554</c:v>
                </c:pt>
              </c:numCache>
            </c:numRef>
          </c:val>
        </c:ser>
        <c:ser>
          <c:idx val="0"/>
          <c:order val="2"/>
          <c:invertIfNegative val="0"/>
          <c:cat>
            <c:strRef>
              <c:f>'[1]ICER Tornado Diagram GBP'!$J$54:$J$63</c:f>
              <c:strCache>
                <c:ptCount val="10"/>
                <c:pt idx="0">
                  <c:v>Probability for complication on the first attempt (UG) lower-/ upper bound of CI</c:v>
                </c:pt>
                <c:pt idx="1">
                  <c:v>Probability for an arterial puncture (LM) lower-/ upper bound of CI</c:v>
                </c:pt>
                <c:pt idx="2">
                  <c:v>Costs of treating haematomediastinum +/- 50% </c:v>
                </c:pt>
                <c:pt idx="3">
                  <c:v>Costs of treating thrombosis +/- 50% </c:v>
                </c:pt>
                <c:pt idx="4">
                  <c:v>Costs of treating embolism +/- 50% </c:v>
                </c:pt>
                <c:pt idx="5">
                  <c:v>Costs of treating hydromediastinum +/- 50% </c:v>
                </c:pt>
                <c:pt idx="6">
                  <c:v>Costs of treating haematothorax +/- 50% </c:v>
                </c:pt>
                <c:pt idx="7">
                  <c:v>Costs of treating pneumothorax +/- 50% </c:v>
                </c:pt>
                <c:pt idx="8">
                  <c:v>Costs of treating hydrothorax +/- 50% </c:v>
                </c:pt>
                <c:pt idx="9">
                  <c:v>Costs of treating nerve injury +/- 50% </c:v>
                </c:pt>
              </c:strCache>
            </c:strRef>
          </c:cat>
          <c:val>
            <c:numRef>
              <c:f>'[1]ICER Tornado Diagram GBP'!$K$33</c:f>
              <c:numCache>
                <c:formatCode>General</c:formatCode>
                <c:ptCount val="1"/>
                <c:pt idx="0">
                  <c:v>-1293.25</c:v>
                </c:pt>
              </c:numCache>
            </c:numRef>
          </c:val>
        </c:ser>
        <c:ser>
          <c:idx val="1"/>
          <c:order val="3"/>
          <c:spPr>
            <a:noFill/>
          </c:spPr>
          <c:invertIfNegative val="0"/>
          <c:cat>
            <c:strRef>
              <c:f>'[1]ICER Tornado Diagram GBP'!$J$54:$J$63</c:f>
              <c:strCache>
                <c:ptCount val="10"/>
                <c:pt idx="0">
                  <c:v>Probability for complication on the first attempt (UG) lower-/ upper bound of CI</c:v>
                </c:pt>
                <c:pt idx="1">
                  <c:v>Probability for an arterial puncture (LM) lower-/ upper bound of CI</c:v>
                </c:pt>
                <c:pt idx="2">
                  <c:v>Costs of treating haematomediastinum +/- 50% </c:v>
                </c:pt>
                <c:pt idx="3">
                  <c:v>Costs of treating thrombosis +/- 50% </c:v>
                </c:pt>
                <c:pt idx="4">
                  <c:v>Costs of treating embolism +/- 50% </c:v>
                </c:pt>
                <c:pt idx="5">
                  <c:v>Costs of treating hydromediastinum +/- 50% </c:v>
                </c:pt>
                <c:pt idx="6">
                  <c:v>Costs of treating haematothorax +/- 50% </c:v>
                </c:pt>
                <c:pt idx="7">
                  <c:v>Costs of treating pneumothorax +/- 50% </c:v>
                </c:pt>
                <c:pt idx="8">
                  <c:v>Costs of treating hydrothorax +/- 50% </c:v>
                </c:pt>
                <c:pt idx="9">
                  <c:v>Costs of treating nerve injury +/- 50% </c:v>
                </c:pt>
              </c:strCache>
            </c:strRef>
          </c:cat>
          <c:val>
            <c:numRef>
              <c:f>'[1]ICER Tornado Diagram GBP'!$K$33</c:f>
              <c:numCache>
                <c:formatCode>General</c:formatCode>
                <c:ptCount val="1"/>
                <c:pt idx="0">
                  <c:v>-1293.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22"/>
        <c:overlap val="100"/>
        <c:axId val="74909184"/>
        <c:axId val="75244672"/>
      </c:barChart>
      <c:catAx>
        <c:axId val="7490918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75244672"/>
        <c:crossesAt val="-1293.5"/>
        <c:auto val="1"/>
        <c:lblAlgn val="ctr"/>
        <c:lblOffset val="100"/>
        <c:noMultiLvlLbl val="0"/>
      </c:catAx>
      <c:valAx>
        <c:axId val="75244672"/>
        <c:scaling>
          <c:orientation val="minMax"/>
          <c:max val="-1100"/>
          <c:min val="-15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cross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74909184"/>
        <c:crosses val="autoZero"/>
        <c:crossBetween val="between"/>
      </c:valAx>
    </c:plotArea>
    <c:plotVisOnly val="1"/>
    <c:dispBlanksAs val="gap"/>
    <c:showDLblsOverMax val="0"/>
  </c:chart>
  <c:spPr>
    <a:ln w="3175">
      <a:noFill/>
    </a:ln>
  </c:spPr>
  <c:txPr>
    <a:bodyPr/>
    <a:lstStyle/>
    <a:p>
      <a:pPr>
        <a:defRPr sz="1100" b="0" i="0" u="none" strike="noStrike" baseline="0">
          <a:solidFill>
            <a:srgbClr val="000000"/>
          </a:solidFill>
          <a:latin typeface="Times New Roman"/>
          <a:ea typeface="Times New Roman"/>
          <a:cs typeface="Times New Roman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3903</cdr:x>
      <cdr:y>0.8193</cdr:y>
    </cdr:from>
    <cdr:to>
      <cdr:x>0.98136</cdr:x>
      <cdr:y>0.87711</cdr:y>
    </cdr:to>
    <cdr:sp macro="" textlink="">
      <cdr:nvSpPr>
        <cdr:cNvPr id="2" name="Rechteck 1"/>
        <cdr:cNvSpPr/>
      </cdr:nvSpPr>
      <cdr:spPr>
        <a:xfrm xmlns:a="http://schemas.openxmlformats.org/drawingml/2006/main">
          <a:off x="4389866" y="3362407"/>
          <a:ext cx="1439434" cy="23725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r>
            <a:rPr lang="de-DE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base-case -</a:t>
          </a:r>
          <a:r>
            <a:rPr lang="de-DE" sz="12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1,1293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6963C-768E-48BC-BF13-CC79C37DE624}" type="datetimeFigureOut">
              <a:rPr lang="en-GB" smtClean="0"/>
              <a:t>08/10/2018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F2DF-521C-4D0E-B6AD-D6FCE3DF11A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2389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6963C-768E-48BC-BF13-CC79C37DE624}" type="datetimeFigureOut">
              <a:rPr lang="en-GB" smtClean="0"/>
              <a:t>08/10/2018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F2DF-521C-4D0E-B6AD-D6FCE3DF11A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4291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6963C-768E-48BC-BF13-CC79C37DE624}" type="datetimeFigureOut">
              <a:rPr lang="en-GB" smtClean="0"/>
              <a:t>08/10/2018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F2DF-521C-4D0E-B6AD-D6FCE3DF11A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5818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6963C-768E-48BC-BF13-CC79C37DE624}" type="datetimeFigureOut">
              <a:rPr lang="en-GB" smtClean="0"/>
              <a:t>08/10/2018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F2DF-521C-4D0E-B6AD-D6FCE3DF11A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6247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6963C-768E-48BC-BF13-CC79C37DE624}" type="datetimeFigureOut">
              <a:rPr lang="en-GB" smtClean="0"/>
              <a:t>08/10/2018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F2DF-521C-4D0E-B6AD-D6FCE3DF11A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0630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6963C-768E-48BC-BF13-CC79C37DE624}" type="datetimeFigureOut">
              <a:rPr lang="en-GB" smtClean="0"/>
              <a:t>08/10/2018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F2DF-521C-4D0E-B6AD-D6FCE3DF11A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5061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6963C-768E-48BC-BF13-CC79C37DE624}" type="datetimeFigureOut">
              <a:rPr lang="en-GB" smtClean="0"/>
              <a:t>08/10/2018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F2DF-521C-4D0E-B6AD-D6FCE3DF11A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1029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6963C-768E-48BC-BF13-CC79C37DE624}" type="datetimeFigureOut">
              <a:rPr lang="en-GB" smtClean="0"/>
              <a:t>08/10/2018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F2DF-521C-4D0E-B6AD-D6FCE3DF11A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9050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6963C-768E-48BC-BF13-CC79C37DE624}" type="datetimeFigureOut">
              <a:rPr lang="en-GB" smtClean="0"/>
              <a:t>08/10/2018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F2DF-521C-4D0E-B6AD-D6FCE3DF11A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49142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6963C-768E-48BC-BF13-CC79C37DE624}" type="datetimeFigureOut">
              <a:rPr lang="en-GB" smtClean="0"/>
              <a:t>08/10/2018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F2DF-521C-4D0E-B6AD-D6FCE3DF11A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4443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6963C-768E-48BC-BF13-CC79C37DE624}" type="datetimeFigureOut">
              <a:rPr lang="en-GB" smtClean="0"/>
              <a:t>08/10/2018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F2DF-521C-4D0E-B6AD-D6FCE3DF11A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4327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F6963C-768E-48BC-BF13-CC79C37DE624}" type="datetimeFigureOut">
              <a:rPr lang="en-GB" smtClean="0"/>
              <a:t>08/10/2018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3AF2DF-521C-4D0E-B6AD-D6FCE3DF11A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4967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pieren 8"/>
          <p:cNvGrpSpPr/>
          <p:nvPr/>
        </p:nvGrpSpPr>
        <p:grpSpPr>
          <a:xfrm>
            <a:off x="1221578" y="980728"/>
            <a:ext cx="6048002" cy="5040560"/>
            <a:chOff x="1221578" y="980728"/>
            <a:chExt cx="6048002" cy="5040560"/>
          </a:xfrm>
        </p:grpSpPr>
        <p:grpSp>
          <p:nvGrpSpPr>
            <p:cNvPr id="3" name="Gruppieren 2"/>
            <p:cNvGrpSpPr/>
            <p:nvPr/>
          </p:nvGrpSpPr>
          <p:grpSpPr>
            <a:xfrm>
              <a:off x="1221580" y="1347255"/>
              <a:ext cx="6048000" cy="4203709"/>
              <a:chOff x="0" y="505883"/>
              <a:chExt cx="6700839" cy="4286257"/>
            </a:xfrm>
          </p:grpSpPr>
          <p:graphicFrame>
            <p:nvGraphicFramePr>
              <p:cNvPr id="6" name="Diagramm 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669846880"/>
                  </p:ext>
                </p:extLst>
              </p:nvPr>
            </p:nvGraphicFramePr>
            <p:xfrm>
              <a:off x="252413" y="534456"/>
              <a:ext cx="6448426" cy="412433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7" name="Rechteck 6"/>
              <p:cNvSpPr/>
              <p:nvPr/>
            </p:nvSpPr>
            <p:spPr bwMode="auto">
              <a:xfrm>
                <a:off x="0" y="505883"/>
                <a:ext cx="328613" cy="397668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270" rtlCol="0" anchor="ctr" anchorCtr="1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GB" sz="1100" b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put</a:t>
                </a:r>
                <a:r>
                  <a:rPr lang="en-GB" sz="1100" b="1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arameters</a:t>
                </a:r>
                <a:endParaRPr lang="en-GB" sz="1100" b="1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Rechteck 7"/>
              <p:cNvSpPr/>
              <p:nvPr/>
            </p:nvSpPr>
            <p:spPr bwMode="auto">
              <a:xfrm rot="5400000">
                <a:off x="4257678" y="2348978"/>
                <a:ext cx="266698" cy="461962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270" rtlCol="0" anchor="ctr" anchorCtr="1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en-GB" sz="1100" b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CER (€/averted</a:t>
                </a:r>
                <a:r>
                  <a:rPr lang="en-GB" sz="1100" b="1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omplication)</a:t>
                </a:r>
                <a:endParaRPr lang="en-GB" sz="1100" b="1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" name="Rechteck 3"/>
            <p:cNvSpPr/>
            <p:nvPr/>
          </p:nvSpPr>
          <p:spPr bwMode="auto">
            <a:xfrm rot="5400000">
              <a:off x="3786283" y="3013867"/>
              <a:ext cx="442716" cy="557212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270" rtlCol="0" anchor="ctr" anchorCtr="1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en-GB" sz="1100" b="0" i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I</a:t>
              </a:r>
              <a:r>
                <a:rPr lang="en-GB" sz="1100" b="0" i="0" baseline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1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nfidence interval,</a:t>
              </a:r>
              <a:r>
                <a:rPr lang="en-GB" sz="1100" b="0" baseline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100" b="0" i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CER</a:t>
              </a:r>
              <a:r>
                <a:rPr lang="en-GB" sz="1100" b="0" i="0" baseline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1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cremental cost-effectiveness ratio</a:t>
              </a:r>
              <a:r>
                <a:rPr lang="en-GB" sz="1100" b="0" baseline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GB" sz="1100" b="0" i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M</a:t>
              </a:r>
              <a:r>
                <a:rPr lang="en-GB" sz="1100" b="0" i="0" baseline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1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andmark method,</a:t>
              </a:r>
              <a:r>
                <a:rPr lang="en-GB" sz="1100" b="0" baseline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100" b="0" i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UG</a:t>
              </a:r>
              <a:r>
                <a:rPr lang="en-GB" sz="1100" b="0" i="0" baseline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1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Ultrasound guidance</a:t>
              </a:r>
            </a:p>
            <a:p>
              <a:pPr algn="l"/>
              <a:endParaRPr lang="en-GB" sz="1100" b="1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hteck 4"/>
            <p:cNvSpPr/>
            <p:nvPr/>
          </p:nvSpPr>
          <p:spPr bwMode="auto">
            <a:xfrm rot="5400000">
              <a:off x="3899290" y="-1696984"/>
              <a:ext cx="477228" cy="583265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270" rtlCol="0" anchor="ctr" anchorCtr="1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en-GB" sz="1100" b="1" i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dditional </a:t>
              </a:r>
              <a:r>
                <a:rPr lang="en-GB" sz="1100" b="1" i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ile 4</a:t>
              </a:r>
              <a:r>
                <a:rPr lang="en-GB" sz="1100" b="0" i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Tornado-diagram presenting the results of the univariate deterministic sensitivity analysis.</a:t>
              </a:r>
              <a:endParaRPr lang="en-GB" sz="1100" b="1" i="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4374039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Bildschirmpräsentation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K-Koel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Yana Seleznova</dc:creator>
  <cp:lastModifiedBy>Yana Seleznova</cp:lastModifiedBy>
  <cp:revision>3</cp:revision>
  <dcterms:created xsi:type="dcterms:W3CDTF">2018-10-08T08:09:25Z</dcterms:created>
  <dcterms:modified xsi:type="dcterms:W3CDTF">2018-10-08T08:33:56Z</dcterms:modified>
</cp:coreProperties>
</file>